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1271F-DB49-4FAE-A2FF-9A0D3BF697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62B24-FE37-4103-845E-CAABCDD10D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3A463-0AE8-4124-A635-C4351AEA0D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FEEAD-DAC8-422A-AF13-71B46C63C0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12969D-C7CF-4777-8211-08CEC125BC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53D40E-9958-43CF-946D-65E840EA80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A571BE-519B-495C-875C-229B4C8AD6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9DEF0-839E-427B-82C3-D21D07933D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C1F67-C22B-49DF-9C27-0CBDA2A176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261813-DC02-4736-A91E-84A7465B08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19BF6D-3768-42DB-AE38-4100F2DE2A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15E47-49BA-4F00-A4BC-DCE52D11E6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EB6F2B-A8E7-4980-B012-063F2F02AFF8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99072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685800" y="1054080"/>
            <a:ext cx="137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ugu_scaffold_38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533412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0" y="76212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457200" y="5181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666880" y="533520"/>
            <a:ext cx="19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Tetraodon_Un_random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0" y="76212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72" name=""/>
          <p:cNvSpPr/>
          <p:nvPr/>
        </p:nvSpPr>
        <p:spPr>
          <a:xfrm>
            <a:off x="1371600" y="609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ugu_scaffold_2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04920" y="5181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0" y="609480"/>
            <a:ext cx="9148680" cy="5173920"/>
          </a:xfrm>
          <a:prstGeom prst="rect">
            <a:avLst/>
          </a:prstGeom>
          <a:ln w="0">
            <a:noFill/>
          </a:ln>
        </p:spPr>
      </p:pic>
      <p:sp>
        <p:nvSpPr>
          <p:cNvPr id="75" name=""/>
          <p:cNvSpPr/>
          <p:nvPr/>
        </p:nvSpPr>
        <p:spPr>
          <a:xfrm>
            <a:off x="457200" y="49528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666880" y="304920"/>
            <a:ext cx="19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Tetraodon_Un_random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" descr=""/>
          <p:cNvPicPr/>
          <p:nvPr/>
        </p:nvPicPr>
        <p:blipFill>
          <a:blip r:embed="rId1"/>
          <a:stretch/>
        </p:blipFill>
        <p:spPr>
          <a:xfrm>
            <a:off x="0" y="838080"/>
            <a:ext cx="9148680" cy="517392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>
            <a:off x="1371600" y="609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ugu_scaffold_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04920" y="5181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" descr=""/>
          <p:cNvPicPr/>
          <p:nvPr/>
        </p:nvPicPr>
        <p:blipFill>
          <a:blip r:embed="rId1"/>
          <a:stretch/>
        </p:blipFill>
        <p:spPr>
          <a:xfrm>
            <a:off x="0" y="838080"/>
            <a:ext cx="9148680" cy="5173920"/>
          </a:xfrm>
          <a:prstGeom prst="rect">
            <a:avLst/>
          </a:prstGeom>
          <a:ln w="0">
            <a:noFill/>
          </a:ln>
        </p:spPr>
      </p:pic>
      <p:sp>
        <p:nvSpPr>
          <p:cNvPr id="81" name=""/>
          <p:cNvSpPr/>
          <p:nvPr/>
        </p:nvSpPr>
        <p:spPr>
          <a:xfrm>
            <a:off x="609480" y="5181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33520" y="609480"/>
            <a:ext cx="19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etraodon_Chromsome_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-4680" y="99072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84" name=""/>
          <p:cNvSpPr/>
          <p:nvPr/>
        </p:nvSpPr>
        <p:spPr>
          <a:xfrm>
            <a:off x="1828800" y="71604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ugu_scaffold_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209680" y="528804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j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0" y="68580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87" name=""/>
          <p:cNvSpPr/>
          <p:nvPr/>
        </p:nvSpPr>
        <p:spPr>
          <a:xfrm>
            <a:off x="1295280" y="502920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j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219320" y="457200"/>
            <a:ext cx="19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etraodon_Chromsome_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0" y="838080"/>
            <a:ext cx="9148680" cy="517392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152280" y="609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ugu_scaffold_2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533520" y="5181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-4680" y="76212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93" name=""/>
          <p:cNvSpPr/>
          <p:nvPr/>
        </p:nvSpPr>
        <p:spPr>
          <a:xfrm>
            <a:off x="457200" y="521172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666880" y="563400"/>
            <a:ext cx="19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Tetraodon_Un_random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0" y="91440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52280" y="601992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85800" y="685800"/>
            <a:ext cx="19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Tetraodon_Chromsome_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-4680" y="838080"/>
            <a:ext cx="9148680" cy="517392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685800" y="53352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ugu_scaffold_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0" y="58672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-4680" y="68580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0" y="579132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33520" y="457200"/>
            <a:ext cx="19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etraodon_Chromsome_1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0" y="609480"/>
            <a:ext cx="9148680" cy="517392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2666880" y="3808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Fugu_scaffold_4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600200" y="49528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0" y="838080"/>
            <a:ext cx="9148680" cy="517392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>
            <a:off x="457200" y="556272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33520" y="609480"/>
            <a:ext cx="19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Tetraodon_Un_random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-4680" y="76212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1371600" y="56340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ugu_scaffold_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04920" y="582120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-4680" y="762120"/>
            <a:ext cx="9148680" cy="517356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457200" y="548640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33520" y="533520"/>
            <a:ext cx="198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Tetraodon_Un_random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-4680" y="838080"/>
            <a:ext cx="9148680" cy="5173920"/>
          </a:xfrm>
          <a:prstGeom prst="rect">
            <a:avLst/>
          </a:prstGeom>
          <a:ln w="0">
            <a:noFill/>
          </a:ln>
        </p:spPr>
      </p:pic>
      <p:sp>
        <p:nvSpPr>
          <p:cNvPr id="66" name=""/>
          <p:cNvSpPr/>
          <p:nvPr/>
        </p:nvSpPr>
        <p:spPr>
          <a:xfrm>
            <a:off x="1371600" y="609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ugu_scaffold_5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04920" y="5181480"/>
            <a:ext cx="13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Diodon_ctf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6T09:28:31Z</dcterms:created>
  <dc:creator>baochengguo</dc:creator>
  <dc:description/>
  <dc:language>en-US</dc:language>
  <cp:lastModifiedBy>guobaocheng</cp:lastModifiedBy>
  <dcterms:modified xsi:type="dcterms:W3CDTF">2009-09-27T13:42:55Z</dcterms:modified>
  <cp:revision>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